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3E5AD4-FF58-4788-977F-2D404F9EA88F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F7D7A3-791E-447F-BB26-34AF9583EEF1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9365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5363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cs-CZ" altLang="cs-CZ" smtClean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74665063-8204-46A9-ABDA-DB5B469E6859}" type="slidenum">
              <a:rPr lang="fr-FR" smtClean="0"/>
              <a:pPr>
                <a:defRPr/>
              </a:pPr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9891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28913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13878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50710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52934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33904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49458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27980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0622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15068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91822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412CE1-9D3B-4E45-B482-AB791EA147D0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C438E-ADB8-4670-8797-CA5C26D18FC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29548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73" name="Group 229"/>
          <p:cNvGraphicFramePr>
            <a:graphicFrameLocks noGrp="1"/>
          </p:cNvGraphicFramePr>
          <p:nvPr>
            <p:ph idx="1"/>
          </p:nvPr>
        </p:nvGraphicFramePr>
        <p:xfrm>
          <a:off x="611188" y="404813"/>
          <a:ext cx="7921625" cy="5748338"/>
        </p:xfrm>
        <a:graphic>
          <a:graphicData uri="http://schemas.openxmlformats.org/drawingml/2006/table">
            <a:tbl>
              <a:tblPr/>
              <a:tblGrid>
                <a:gridCol w="1008062"/>
                <a:gridCol w="1081088"/>
                <a:gridCol w="1079500"/>
                <a:gridCol w="1223962"/>
                <a:gridCol w="1204913"/>
                <a:gridCol w="1123950"/>
                <a:gridCol w="1200150"/>
              </a:tblGrid>
              <a:tr h="37623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K metabolite</a:t>
                      </a: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474" marR="8474" marT="847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W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t3 KO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2889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474" marR="8474" marT="847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gridSpan="4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pmol/ g FW</a:t>
                      </a:r>
                    </a:p>
                  </a:txBody>
                  <a:tcPr marL="8081" marR="8081" marT="8082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1" marR="8081" marT="8082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637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25 ± 0.2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01 ± 0.5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62 ± 0.5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28 ± 0.3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76 ± 0.2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7 ± 0.9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R</a:t>
                      </a: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.65 ± 0.1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23 ± 1.1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.58 ± 0.6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.90 ± 0,3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8.77 ± 0.8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1.29 ± 1.7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8 ± 0.0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0 ± 0.0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0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2 ± 0.0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1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4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R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7 ± 0.0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5 ± 0.0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2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77 ± 0.0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3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7 ± 0.0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43 ± 0.0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3 ± 0.1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94 ± 0.0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6 ± 0.0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11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40 ± 0.1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R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31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98 ± 0.1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91 ± 0.1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27 ± 1.1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29 ± 0.3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48 ± 0.7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1 ± 0.0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23 ± 0.0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9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5 ± 0.0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45 ± 0.1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7 ± 0,1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R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48 ± 0.1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3 ± 0.0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0 ± 0.3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82 ± 0.4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70 ± 0.0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13 ± 0.0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O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9.13 ± 5.0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6.79 ± 2.0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9.52 ± 1.9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7.26 ± 3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0.37 ± 1.6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5.85 ± 1.3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RO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27 ± 0.7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69 ± 0.3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47 ± 0.4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3 ± 0.2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74 ± 0.6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03 ± 1.2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RO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43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5 ± 0.0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02 ± 0.4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92 ± 0.7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32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12 ± 0.4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RO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39 ± 0.2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27 ± 1.0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16 ±  0.1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0 ± 0.1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98 ± 1.2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24 ± 0.1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O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0 ± 0.0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5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8 ± 0.1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3 ± 0.0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2 ± 0.0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25 ± 0.1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7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5.38 ± 4.5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3.98 ± 0.6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3.04 ± 2.8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5.79 ± 3.7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2.48 ± 5.1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2.63 ± 1.5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9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48 ± 0.0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10 ± 0.6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26 ± 0.6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11 ± 0.7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.48 ± 1.7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33 ± 0.1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7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8.88 ± 1.1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7 ± 0.0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63 ± 0.2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36 ± 1.3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57 ± 0.6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87 ± 0.2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9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51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6 ± 0.1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24 ± 0.1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1 ± 0.1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52 ± 0.0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17 ± 0.0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7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7.15 ± 0.1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2.01 ± 3.4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9.29 ± 2.2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2.24 ± 2.7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1.62 ± 3.5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4.10 ± 3.9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9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91 ± 0.0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9 ± 0.0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5 ± 0.0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1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77 ± 0.0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37 ± 0.2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7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6.54 ± 0.7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7.37 ± 7.9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0.36 ± 10.6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4.33 ± 8.3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56.17 ± 33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29.87 ± 15.9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9G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07 ± 0.4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56 ± 0.7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29 ± 0.1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23 ± 0.2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82 ± 1.4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5 ± 0.7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RMP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6.69 ± 4.0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2.77 ± 1.9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1.54 ± 3.8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0.65 ± 5.65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4.68 ± 3.4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7.04 ± 1.6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HZRMP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7 ± 0.2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2 ± 0.16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1 ± 0.0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96 ± 0.1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75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70 ± 0.0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RMP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90 ± 0.21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67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69 ± 1.17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77 ± 0.5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89 ± 1.2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42 ± 0.08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32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RMP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8.10 ± 0.00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8.76 ± 0.54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8.51 ± 1.82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8.63 ± 1.3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6.57 ± 3.83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2.43 ± 2.39</a:t>
                      </a:r>
                    </a:p>
                  </a:txBody>
                  <a:tcPr marL="9524" marR="9524" marT="9525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4324" name="Obdélník 1"/>
          <p:cNvSpPr>
            <a:spLocks noChangeArrowheads="1"/>
          </p:cNvSpPr>
          <p:nvPr/>
        </p:nvSpPr>
        <p:spPr bwMode="auto">
          <a:xfrm>
            <a:off x="0" y="6308725"/>
            <a:ext cx="91440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file 3. Endogenous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CK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content (pmol/ g fresh weight) of 17 DAS Arabidopsis </a:t>
            </a:r>
            <a:r>
              <a:rPr lang="fr-FR" altLang="cs-CZ" sz="1200" b="1" i="1">
                <a:latin typeface="Helvetica" pitchFamily="34" charset="0"/>
                <a:cs typeface="Helvetica" pitchFamily="34" charset="0"/>
              </a:rPr>
              <a:t>ipt3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 plants complemented with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or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4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and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grown on 100 mM NaCl medium. </a:t>
            </a:r>
          </a:p>
        </p:txBody>
      </p:sp>
    </p:spTree>
    <p:extLst>
      <p:ext uri="{BB962C8B-B14F-4D97-AF65-F5344CB8AC3E}">
        <p14:creationId xmlns:p14="http://schemas.microsoft.com/office/powerpoint/2010/main" val="9427391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2</Words>
  <Application>Microsoft Office PowerPoint</Application>
  <PresentationFormat>Předvádění na obrazovce (4:3)</PresentationFormat>
  <Paragraphs>185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0:54Z</dcterms:created>
  <dcterms:modified xsi:type="dcterms:W3CDTF">2014-10-10T16:01:19Z</dcterms:modified>
</cp:coreProperties>
</file>